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AC3CE76-D5F4-4A85-BF79-F742DE8321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6610159"/>
              </p:ext>
            </p:extLst>
          </p:nvPr>
        </p:nvGraphicFramePr>
        <p:xfrm>
          <a:off x="5179777" y="1271073"/>
          <a:ext cx="3419475" cy="3384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420000" imgH="3384000" progId="Prism5.Document">
                  <p:embed/>
                </p:oleObj>
              </mc:Choice>
              <mc:Fallback>
                <p:oleObj name="Prism Project" r:id="rId2" imgW="3420000" imgH="338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79777" y="1271073"/>
                        <a:ext cx="3419475" cy="3384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4AD08BB-D393-4AE5-BBDF-406FDF9DE2B9}"/>
              </a:ext>
            </a:extLst>
          </p:cNvPr>
          <p:cNvSpPr txBox="1"/>
          <p:nvPr/>
        </p:nvSpPr>
        <p:spPr>
          <a:xfrm>
            <a:off x="5851081" y="809408"/>
            <a:ext cx="16065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V-specific IgG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titers in SIC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E892F8-6BFE-4966-A082-AC7D1AB6519D}"/>
              </a:ext>
            </a:extLst>
          </p:cNvPr>
          <p:cNvSpPr txBox="1"/>
          <p:nvPr/>
        </p:nvSpPr>
        <p:spPr>
          <a:xfrm>
            <a:off x="915962" y="4517123"/>
            <a:ext cx="77926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8 Fig.</a:t>
            </a:r>
            <a:r>
              <a:rPr lang="en-US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(a) and HRV-specific IgG (b) in EcN biofilm, EcN suspension, and control pigs in small intestinal contents (SIC)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represented means ± SEM. Gnotobiotic pigs were transplanted with human infant fecal microbiota (HIFM) at 4 days of age, post-HIFM transplantation day (PTD) 0. Pigs were fed protein deficient diet. Probiotic was given to respective groups at PTD 11, challenged with virulent human rotavirus (VirHRV) on PTD13/post-challenge day (PCD) 0 and euthanized on PTD 27/PCD 14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92EF0A2-DA51-4BFD-B38C-AE8B2A847E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9593424"/>
              </p:ext>
            </p:extLst>
          </p:nvPr>
        </p:nvGraphicFramePr>
        <p:xfrm>
          <a:off x="472330" y="937245"/>
          <a:ext cx="3492500" cy="352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3492000" imgH="3528000" progId="Prism5.Document">
                  <p:embed/>
                </p:oleObj>
              </mc:Choice>
              <mc:Fallback>
                <p:oleObj name="Prism Project" r:id="rId4" imgW="3492000" imgH="35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2330" y="937245"/>
                        <a:ext cx="3492500" cy="352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0CD86420-C876-4009-A3E8-7171E77D6711}"/>
              </a:ext>
            </a:extLst>
          </p:cNvPr>
          <p:cNvSpPr txBox="1"/>
          <p:nvPr/>
        </p:nvSpPr>
        <p:spPr>
          <a:xfrm>
            <a:off x="306198" y="763241"/>
            <a:ext cx="6094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9A723B-95EF-4621-930E-166C14590037}"/>
              </a:ext>
            </a:extLst>
          </p:cNvPr>
          <p:cNvSpPr txBox="1"/>
          <p:nvPr/>
        </p:nvSpPr>
        <p:spPr>
          <a:xfrm>
            <a:off x="4812266" y="804619"/>
            <a:ext cx="6094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88610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11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9:43Z</dcterms:modified>
</cp:coreProperties>
</file>